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82" d="100"/>
          <a:sy n="82" d="100"/>
        </p:scale>
        <p:origin x="-90" y="-63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K:\&#22679;&#28181;&#35029;&#26391;\TRPV2\phagocytosis\&#12464;&#12521;&#12501;\&#35542;&#25991;&#29992;\&#25237;&#31295;\CSE%2010%25%2024h%20&#25913;&#23450;%20&#26032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91C-4FF2-A390-D8B951B17E7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91C-4FF2-A390-D8B951B17E7D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D$57:$D$58</c:f>
                <c:numCache>
                  <c:formatCode>General</c:formatCode>
                  <c:ptCount val="2"/>
                  <c:pt idx="0">
                    <c:v>0.33948114487397757</c:v>
                  </c:pt>
                  <c:pt idx="1">
                    <c:v>0.3806799588936452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sq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57:$B$58</c:f>
              <c:strCache>
                <c:ptCount val="2"/>
                <c:pt idx="0">
                  <c:v>vehicle</c:v>
                </c:pt>
                <c:pt idx="1">
                  <c:v>10%CSE 24h</c:v>
                </c:pt>
              </c:strCache>
            </c:strRef>
          </c:cat>
          <c:val>
            <c:numRef>
              <c:f>Sheet1!$C$57:$C$58</c:f>
              <c:numCache>
                <c:formatCode>@</c:formatCode>
                <c:ptCount val="2"/>
                <c:pt idx="0">
                  <c:v>1.5006395047987262</c:v>
                </c:pt>
                <c:pt idx="1">
                  <c:v>3.76819659646759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91C-4FF2-A390-D8B951B17E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94"/>
        <c:overlap val="-18"/>
        <c:axId val="74980352"/>
        <c:axId val="75354880"/>
      </c:barChart>
      <c:catAx>
        <c:axId val="749803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5354880"/>
        <c:crosses val="autoZero"/>
        <c:auto val="1"/>
        <c:lblAlgn val="ctr"/>
        <c:lblOffset val="100"/>
        <c:noMultiLvlLbl val="0"/>
      </c:catAx>
      <c:valAx>
        <c:axId val="75354880"/>
        <c:scaling>
          <c:orientation val="minMax"/>
        </c:scaling>
        <c:delete val="0"/>
        <c:axPos val="l"/>
        <c:numFmt formatCode="@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49803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5813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5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0741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7055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8410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0873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278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85815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675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5441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1505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D6CCBC-CF1E-40E3-82E4-8EA864A41E01}" type="datetimeFigureOut">
              <a:rPr kumimoji="1" lang="ja-JP" altLang="en-US" smtClean="0"/>
              <a:t>2019/3/1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4E953-0EAA-4D14-861E-1F9CBE1574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90621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55346541"/>
              </p:ext>
            </p:extLst>
          </p:nvPr>
        </p:nvGraphicFramePr>
        <p:xfrm>
          <a:off x="3008931" y="1451609"/>
          <a:ext cx="2199740" cy="37376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テキスト ボックス 4"/>
          <p:cNvSpPr txBox="1"/>
          <p:nvPr/>
        </p:nvSpPr>
        <p:spPr>
          <a:xfrm rot="16200000" flipH="1">
            <a:off x="546429" y="3151137"/>
            <a:ext cx="433808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b="1" dirty="0" smtClean="0">
                <a:latin typeface="Calibri" panose="020F0502020204030204" pitchFamily="34" charset="0"/>
              </a:rPr>
              <a:t>Fold change of  luminescence intensity </a:t>
            </a:r>
          </a:p>
        </p:txBody>
      </p:sp>
      <p:sp>
        <p:nvSpPr>
          <p:cNvPr id="6" name="テキスト ボックス 5"/>
          <p:cNvSpPr txBox="1"/>
          <p:nvPr/>
        </p:nvSpPr>
        <p:spPr>
          <a:xfrm rot="18786142">
            <a:off x="3947807" y="5004553"/>
            <a:ext cx="15551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 smtClean="0">
                <a:latin typeface="Calibri" panose="020F0502020204030204" pitchFamily="34" charset="0"/>
              </a:rPr>
              <a:t>10%CSE</a:t>
            </a:r>
            <a:endParaRPr kumimoji="1" lang="ja-JP" altLang="en-US" b="1" dirty="0">
              <a:latin typeface="Calibri" panose="020F050202020403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8786142">
            <a:off x="2989908" y="5197802"/>
            <a:ext cx="1555113" cy="3753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 smtClean="0">
                <a:latin typeface="Calibri" panose="020F0502020204030204" pitchFamily="34" charset="0"/>
              </a:rPr>
              <a:t>vehicle</a:t>
            </a:r>
            <a:endParaRPr kumimoji="1" lang="ja-JP" altLang="en-US" b="1" dirty="0">
              <a:latin typeface="Calibri" panose="020F050202020403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35226" y="174051"/>
            <a:ext cx="375134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2400" b="1" kern="100" dirty="0" smtClean="0">
                <a:solidFill>
                  <a:srgbClr val="000000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2400" b="1" kern="100" smtClean="0">
                <a:solidFill>
                  <a:srgbClr val="000000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</a:t>
            </a:r>
            <a:r>
              <a:rPr lang="en-US" altLang="ja-JP" sz="2400" b="1" kern="100" smtClean="0">
                <a:solidFill>
                  <a:srgbClr val="000000"/>
                </a:solidFill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 </a:t>
            </a:r>
            <a:endParaRPr lang="en-US" altLang="ja-JP" sz="2400" b="1" kern="100" dirty="0">
              <a:solidFill>
                <a:srgbClr val="000000"/>
              </a:solidFill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87692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増渕裕朗</dc:creator>
  <cp:lastModifiedBy>Capangan, Fritz</cp:lastModifiedBy>
  <cp:revision>7</cp:revision>
  <dcterms:created xsi:type="dcterms:W3CDTF">2018-10-30T07:40:13Z</dcterms:created>
  <dcterms:modified xsi:type="dcterms:W3CDTF">2019-03-13T22:49:47Z</dcterms:modified>
</cp:coreProperties>
</file>